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57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65" d="100"/>
          <a:sy n="65" d="100"/>
        </p:scale>
        <p:origin x="2405" y="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hosh, Souvik" userId="eecea02d-3ead-4d19-9bc6-c58aca595acd" providerId="ADAL" clId="{EB6CA0CA-B841-4CC5-9E0D-502717CC05FA}"/>
    <pc:docChg chg="undo custSel modSld modMainMaster">
      <pc:chgData name="Ghosh, Souvik" userId="eecea02d-3ead-4d19-9bc6-c58aca595acd" providerId="ADAL" clId="{EB6CA0CA-B841-4CC5-9E0D-502717CC05FA}" dt="2022-11-05T13:14:43.123" v="406" actId="20577"/>
      <pc:docMkLst>
        <pc:docMk/>
      </pc:docMkLst>
      <pc:sldChg chg="addSp modSp mod">
        <pc:chgData name="Ghosh, Souvik" userId="eecea02d-3ead-4d19-9bc6-c58aca595acd" providerId="ADAL" clId="{EB6CA0CA-B841-4CC5-9E0D-502717CC05FA}" dt="2022-11-05T13:14:43.123" v="406" actId="20577"/>
        <pc:sldMkLst>
          <pc:docMk/>
          <pc:sldMk cId="2112372656" sldId="257"/>
        </pc:sldMkLst>
        <pc:spChg chg="add mod">
          <ac:chgData name="Ghosh, Souvik" userId="eecea02d-3ead-4d19-9bc6-c58aca595acd" providerId="ADAL" clId="{EB6CA0CA-B841-4CC5-9E0D-502717CC05FA}" dt="2022-11-05T13:14:43.123" v="406" actId="20577"/>
          <ac:spMkLst>
            <pc:docMk/>
            <pc:sldMk cId="2112372656" sldId="257"/>
            <ac:spMk id="4" creationId="{29D384DA-1FB8-7FF3-0040-8C715698B107}"/>
          </ac:spMkLst>
        </pc:spChg>
        <pc:picChg chg="mod">
          <ac:chgData name="Ghosh, Souvik" userId="eecea02d-3ead-4d19-9bc6-c58aca595acd" providerId="ADAL" clId="{EB6CA0CA-B841-4CC5-9E0D-502717CC05FA}" dt="2022-10-31T15:11:44.453" v="208" actId="1076"/>
          <ac:picMkLst>
            <pc:docMk/>
            <pc:sldMk cId="2112372656" sldId="257"/>
            <ac:picMk id="3" creationId="{E719FB7E-9452-4B63-ACD7-52EB685A922B}"/>
          </ac:picMkLst>
        </pc:picChg>
      </pc:sldChg>
      <pc:sldMasterChg chg="modSp modSldLayout">
        <pc:chgData name="Ghosh, Souvik" userId="eecea02d-3ead-4d19-9bc6-c58aca595acd" providerId="ADAL" clId="{EB6CA0CA-B841-4CC5-9E0D-502717CC05FA}" dt="2022-10-31T15:04:53.889" v="0"/>
        <pc:sldMasterMkLst>
          <pc:docMk/>
          <pc:sldMasterMk cId="4045597202" sldId="2147483648"/>
        </pc:sldMasterMkLst>
        <pc:spChg chg="mod">
          <ac:chgData name="Ghosh, Souvik" userId="eecea02d-3ead-4d19-9bc6-c58aca595acd" providerId="ADAL" clId="{EB6CA0CA-B841-4CC5-9E0D-502717CC05FA}" dt="2022-10-31T15:04:53.889" v="0"/>
          <ac:spMkLst>
            <pc:docMk/>
            <pc:sldMasterMk cId="4045597202" sldId="2147483648"/>
            <ac:spMk id="2" creationId="{485237CC-C479-4E5C-B984-D17E55C9461E}"/>
          </ac:spMkLst>
        </pc:spChg>
        <pc:spChg chg="mod">
          <ac:chgData name="Ghosh, Souvik" userId="eecea02d-3ead-4d19-9bc6-c58aca595acd" providerId="ADAL" clId="{EB6CA0CA-B841-4CC5-9E0D-502717CC05FA}" dt="2022-10-31T15:04:53.889" v="0"/>
          <ac:spMkLst>
            <pc:docMk/>
            <pc:sldMasterMk cId="4045597202" sldId="2147483648"/>
            <ac:spMk id="3" creationId="{7B4AD940-5994-4D6C-83A2-2A01F6D84C17}"/>
          </ac:spMkLst>
        </pc:spChg>
        <pc:spChg chg="mod">
          <ac:chgData name="Ghosh, Souvik" userId="eecea02d-3ead-4d19-9bc6-c58aca595acd" providerId="ADAL" clId="{EB6CA0CA-B841-4CC5-9E0D-502717CC05FA}" dt="2022-10-31T15:04:53.889" v="0"/>
          <ac:spMkLst>
            <pc:docMk/>
            <pc:sldMasterMk cId="4045597202" sldId="2147483648"/>
            <ac:spMk id="4" creationId="{8D174035-4AFD-4F0C-81AC-004614001495}"/>
          </ac:spMkLst>
        </pc:spChg>
        <pc:spChg chg="mod">
          <ac:chgData name="Ghosh, Souvik" userId="eecea02d-3ead-4d19-9bc6-c58aca595acd" providerId="ADAL" clId="{EB6CA0CA-B841-4CC5-9E0D-502717CC05FA}" dt="2022-10-31T15:04:53.889" v="0"/>
          <ac:spMkLst>
            <pc:docMk/>
            <pc:sldMasterMk cId="4045597202" sldId="2147483648"/>
            <ac:spMk id="5" creationId="{65C5193E-C8DC-473C-967A-892EA0CBD058}"/>
          </ac:spMkLst>
        </pc:spChg>
        <pc:spChg chg="mod">
          <ac:chgData name="Ghosh, Souvik" userId="eecea02d-3ead-4d19-9bc6-c58aca595acd" providerId="ADAL" clId="{EB6CA0CA-B841-4CC5-9E0D-502717CC05FA}" dt="2022-10-31T15:04:53.889" v="0"/>
          <ac:spMkLst>
            <pc:docMk/>
            <pc:sldMasterMk cId="4045597202" sldId="2147483648"/>
            <ac:spMk id="6" creationId="{F229FA01-ACAB-4503-AF3E-60C28F7A1380}"/>
          </ac:spMkLst>
        </pc:spChg>
        <pc:sldLayoutChg chg="modSp">
          <pc:chgData name="Ghosh, Souvik" userId="eecea02d-3ead-4d19-9bc6-c58aca595acd" providerId="ADAL" clId="{EB6CA0CA-B841-4CC5-9E0D-502717CC05FA}" dt="2022-10-31T15:04:53.889" v="0"/>
          <pc:sldLayoutMkLst>
            <pc:docMk/>
            <pc:sldMasterMk cId="4045597202" sldId="2147483648"/>
            <pc:sldLayoutMk cId="79175091" sldId="2147483649"/>
          </pc:sldLayoutMkLst>
          <pc:spChg chg="mod">
            <ac:chgData name="Ghosh, Souvik" userId="eecea02d-3ead-4d19-9bc6-c58aca595acd" providerId="ADAL" clId="{EB6CA0CA-B841-4CC5-9E0D-502717CC05FA}" dt="2022-10-31T15:04:53.889" v="0"/>
            <ac:spMkLst>
              <pc:docMk/>
              <pc:sldMasterMk cId="4045597202" sldId="2147483648"/>
              <pc:sldLayoutMk cId="79175091" sldId="2147483649"/>
              <ac:spMk id="2" creationId="{34F38634-CEFE-47DE-81FE-D67222A9D1C8}"/>
            </ac:spMkLst>
          </pc:spChg>
          <pc:spChg chg="mod">
            <ac:chgData name="Ghosh, Souvik" userId="eecea02d-3ead-4d19-9bc6-c58aca595acd" providerId="ADAL" clId="{EB6CA0CA-B841-4CC5-9E0D-502717CC05FA}" dt="2022-10-31T15:04:53.889" v="0"/>
            <ac:spMkLst>
              <pc:docMk/>
              <pc:sldMasterMk cId="4045597202" sldId="2147483648"/>
              <pc:sldLayoutMk cId="79175091" sldId="2147483649"/>
              <ac:spMk id="3" creationId="{106ADC29-C5FA-4781-9E8B-560A1DFA254E}"/>
            </ac:spMkLst>
          </pc:spChg>
        </pc:sldLayoutChg>
        <pc:sldLayoutChg chg="modSp">
          <pc:chgData name="Ghosh, Souvik" userId="eecea02d-3ead-4d19-9bc6-c58aca595acd" providerId="ADAL" clId="{EB6CA0CA-B841-4CC5-9E0D-502717CC05FA}" dt="2022-10-31T15:04:53.889" v="0"/>
          <pc:sldLayoutMkLst>
            <pc:docMk/>
            <pc:sldMasterMk cId="4045597202" sldId="2147483648"/>
            <pc:sldLayoutMk cId="1725307700" sldId="2147483651"/>
          </pc:sldLayoutMkLst>
          <pc:spChg chg="mod">
            <ac:chgData name="Ghosh, Souvik" userId="eecea02d-3ead-4d19-9bc6-c58aca595acd" providerId="ADAL" clId="{EB6CA0CA-B841-4CC5-9E0D-502717CC05FA}" dt="2022-10-31T15:04:53.889" v="0"/>
            <ac:spMkLst>
              <pc:docMk/>
              <pc:sldMasterMk cId="4045597202" sldId="2147483648"/>
              <pc:sldLayoutMk cId="1725307700" sldId="2147483651"/>
              <ac:spMk id="2" creationId="{AE136191-280C-45C9-B63D-C5DEFF1420F7}"/>
            </ac:spMkLst>
          </pc:spChg>
          <pc:spChg chg="mod">
            <ac:chgData name="Ghosh, Souvik" userId="eecea02d-3ead-4d19-9bc6-c58aca595acd" providerId="ADAL" clId="{EB6CA0CA-B841-4CC5-9E0D-502717CC05FA}" dt="2022-10-31T15:04:53.889" v="0"/>
            <ac:spMkLst>
              <pc:docMk/>
              <pc:sldMasterMk cId="4045597202" sldId="2147483648"/>
              <pc:sldLayoutMk cId="1725307700" sldId="2147483651"/>
              <ac:spMk id="3" creationId="{C2431A8E-D69E-43F1-B4B2-B56340C2AD14}"/>
            </ac:spMkLst>
          </pc:spChg>
        </pc:sldLayoutChg>
        <pc:sldLayoutChg chg="modSp">
          <pc:chgData name="Ghosh, Souvik" userId="eecea02d-3ead-4d19-9bc6-c58aca595acd" providerId="ADAL" clId="{EB6CA0CA-B841-4CC5-9E0D-502717CC05FA}" dt="2022-10-31T15:04:53.889" v="0"/>
          <pc:sldLayoutMkLst>
            <pc:docMk/>
            <pc:sldMasterMk cId="4045597202" sldId="2147483648"/>
            <pc:sldLayoutMk cId="383172637" sldId="2147483652"/>
          </pc:sldLayoutMkLst>
          <pc:spChg chg="mod">
            <ac:chgData name="Ghosh, Souvik" userId="eecea02d-3ead-4d19-9bc6-c58aca595acd" providerId="ADAL" clId="{EB6CA0CA-B841-4CC5-9E0D-502717CC05FA}" dt="2022-10-31T15:04:53.889" v="0"/>
            <ac:spMkLst>
              <pc:docMk/>
              <pc:sldMasterMk cId="4045597202" sldId="2147483648"/>
              <pc:sldLayoutMk cId="383172637" sldId="2147483652"/>
              <ac:spMk id="3" creationId="{0E26566A-251A-486C-AFE2-9932D9110256}"/>
            </ac:spMkLst>
          </pc:spChg>
          <pc:spChg chg="mod">
            <ac:chgData name="Ghosh, Souvik" userId="eecea02d-3ead-4d19-9bc6-c58aca595acd" providerId="ADAL" clId="{EB6CA0CA-B841-4CC5-9E0D-502717CC05FA}" dt="2022-10-31T15:04:53.889" v="0"/>
            <ac:spMkLst>
              <pc:docMk/>
              <pc:sldMasterMk cId="4045597202" sldId="2147483648"/>
              <pc:sldLayoutMk cId="383172637" sldId="2147483652"/>
              <ac:spMk id="4" creationId="{41D02E5A-EB0D-4E83-8BE2-1740CE541286}"/>
            </ac:spMkLst>
          </pc:spChg>
        </pc:sldLayoutChg>
        <pc:sldLayoutChg chg="modSp">
          <pc:chgData name="Ghosh, Souvik" userId="eecea02d-3ead-4d19-9bc6-c58aca595acd" providerId="ADAL" clId="{EB6CA0CA-B841-4CC5-9E0D-502717CC05FA}" dt="2022-10-31T15:04:53.889" v="0"/>
          <pc:sldLayoutMkLst>
            <pc:docMk/>
            <pc:sldMasterMk cId="4045597202" sldId="2147483648"/>
            <pc:sldLayoutMk cId="2769109195" sldId="2147483653"/>
          </pc:sldLayoutMkLst>
          <pc:spChg chg="mod">
            <ac:chgData name="Ghosh, Souvik" userId="eecea02d-3ead-4d19-9bc6-c58aca595acd" providerId="ADAL" clId="{EB6CA0CA-B841-4CC5-9E0D-502717CC05FA}" dt="2022-10-31T15:04:53.889" v="0"/>
            <ac:spMkLst>
              <pc:docMk/>
              <pc:sldMasterMk cId="4045597202" sldId="2147483648"/>
              <pc:sldLayoutMk cId="2769109195" sldId="2147483653"/>
              <ac:spMk id="2" creationId="{45BAFD0A-4D2B-48C5-A63D-D9FC928A6A8C}"/>
            </ac:spMkLst>
          </pc:spChg>
          <pc:spChg chg="mod">
            <ac:chgData name="Ghosh, Souvik" userId="eecea02d-3ead-4d19-9bc6-c58aca595acd" providerId="ADAL" clId="{EB6CA0CA-B841-4CC5-9E0D-502717CC05FA}" dt="2022-10-31T15:04:53.889" v="0"/>
            <ac:spMkLst>
              <pc:docMk/>
              <pc:sldMasterMk cId="4045597202" sldId="2147483648"/>
              <pc:sldLayoutMk cId="2769109195" sldId="2147483653"/>
              <ac:spMk id="3" creationId="{C4269E15-2FFD-427F-B734-BF19E89E58FC}"/>
            </ac:spMkLst>
          </pc:spChg>
          <pc:spChg chg="mod">
            <ac:chgData name="Ghosh, Souvik" userId="eecea02d-3ead-4d19-9bc6-c58aca595acd" providerId="ADAL" clId="{EB6CA0CA-B841-4CC5-9E0D-502717CC05FA}" dt="2022-10-31T15:04:53.889" v="0"/>
            <ac:spMkLst>
              <pc:docMk/>
              <pc:sldMasterMk cId="4045597202" sldId="2147483648"/>
              <pc:sldLayoutMk cId="2769109195" sldId="2147483653"/>
              <ac:spMk id="4" creationId="{8DDA416B-DED3-4E47-83F0-8A79C0B2E9ED}"/>
            </ac:spMkLst>
          </pc:spChg>
          <pc:spChg chg="mod">
            <ac:chgData name="Ghosh, Souvik" userId="eecea02d-3ead-4d19-9bc6-c58aca595acd" providerId="ADAL" clId="{EB6CA0CA-B841-4CC5-9E0D-502717CC05FA}" dt="2022-10-31T15:04:53.889" v="0"/>
            <ac:spMkLst>
              <pc:docMk/>
              <pc:sldMasterMk cId="4045597202" sldId="2147483648"/>
              <pc:sldLayoutMk cId="2769109195" sldId="2147483653"/>
              <ac:spMk id="5" creationId="{B2B1C2C3-8317-43A9-87E9-D1E822CBF667}"/>
            </ac:spMkLst>
          </pc:spChg>
          <pc:spChg chg="mod">
            <ac:chgData name="Ghosh, Souvik" userId="eecea02d-3ead-4d19-9bc6-c58aca595acd" providerId="ADAL" clId="{EB6CA0CA-B841-4CC5-9E0D-502717CC05FA}" dt="2022-10-31T15:04:53.889" v="0"/>
            <ac:spMkLst>
              <pc:docMk/>
              <pc:sldMasterMk cId="4045597202" sldId="2147483648"/>
              <pc:sldLayoutMk cId="2769109195" sldId="2147483653"/>
              <ac:spMk id="6" creationId="{0D91FD04-AE10-4E58-B90F-65C4E854FF4C}"/>
            </ac:spMkLst>
          </pc:spChg>
        </pc:sldLayoutChg>
        <pc:sldLayoutChg chg="modSp">
          <pc:chgData name="Ghosh, Souvik" userId="eecea02d-3ead-4d19-9bc6-c58aca595acd" providerId="ADAL" clId="{EB6CA0CA-B841-4CC5-9E0D-502717CC05FA}" dt="2022-10-31T15:04:53.889" v="0"/>
          <pc:sldLayoutMkLst>
            <pc:docMk/>
            <pc:sldMasterMk cId="4045597202" sldId="2147483648"/>
            <pc:sldLayoutMk cId="4089767499" sldId="2147483656"/>
          </pc:sldLayoutMkLst>
          <pc:spChg chg="mod">
            <ac:chgData name="Ghosh, Souvik" userId="eecea02d-3ead-4d19-9bc6-c58aca595acd" providerId="ADAL" clId="{EB6CA0CA-B841-4CC5-9E0D-502717CC05FA}" dt="2022-10-31T15:04:53.889" v="0"/>
            <ac:spMkLst>
              <pc:docMk/>
              <pc:sldMasterMk cId="4045597202" sldId="2147483648"/>
              <pc:sldLayoutMk cId="4089767499" sldId="2147483656"/>
              <ac:spMk id="2" creationId="{E9171600-13F0-4AAB-94A7-2479357713B8}"/>
            </ac:spMkLst>
          </pc:spChg>
          <pc:spChg chg="mod">
            <ac:chgData name="Ghosh, Souvik" userId="eecea02d-3ead-4d19-9bc6-c58aca595acd" providerId="ADAL" clId="{EB6CA0CA-B841-4CC5-9E0D-502717CC05FA}" dt="2022-10-31T15:04:53.889" v="0"/>
            <ac:spMkLst>
              <pc:docMk/>
              <pc:sldMasterMk cId="4045597202" sldId="2147483648"/>
              <pc:sldLayoutMk cId="4089767499" sldId="2147483656"/>
              <ac:spMk id="3" creationId="{4FEDA662-ED0C-4C15-BAD9-76EECBBF1A4E}"/>
            </ac:spMkLst>
          </pc:spChg>
          <pc:spChg chg="mod">
            <ac:chgData name="Ghosh, Souvik" userId="eecea02d-3ead-4d19-9bc6-c58aca595acd" providerId="ADAL" clId="{EB6CA0CA-B841-4CC5-9E0D-502717CC05FA}" dt="2022-10-31T15:04:53.889" v="0"/>
            <ac:spMkLst>
              <pc:docMk/>
              <pc:sldMasterMk cId="4045597202" sldId="2147483648"/>
              <pc:sldLayoutMk cId="4089767499" sldId="2147483656"/>
              <ac:spMk id="4" creationId="{BF525491-C79D-47CB-9E0B-715A5D401439}"/>
            </ac:spMkLst>
          </pc:spChg>
        </pc:sldLayoutChg>
        <pc:sldLayoutChg chg="modSp">
          <pc:chgData name="Ghosh, Souvik" userId="eecea02d-3ead-4d19-9bc6-c58aca595acd" providerId="ADAL" clId="{EB6CA0CA-B841-4CC5-9E0D-502717CC05FA}" dt="2022-10-31T15:04:53.889" v="0"/>
          <pc:sldLayoutMkLst>
            <pc:docMk/>
            <pc:sldMasterMk cId="4045597202" sldId="2147483648"/>
            <pc:sldLayoutMk cId="190809347" sldId="2147483657"/>
          </pc:sldLayoutMkLst>
          <pc:spChg chg="mod">
            <ac:chgData name="Ghosh, Souvik" userId="eecea02d-3ead-4d19-9bc6-c58aca595acd" providerId="ADAL" clId="{EB6CA0CA-B841-4CC5-9E0D-502717CC05FA}" dt="2022-10-31T15:04:53.889" v="0"/>
            <ac:spMkLst>
              <pc:docMk/>
              <pc:sldMasterMk cId="4045597202" sldId="2147483648"/>
              <pc:sldLayoutMk cId="190809347" sldId="2147483657"/>
              <ac:spMk id="2" creationId="{B02BEA37-2A98-411F-A8C0-D75889CCBC57}"/>
            </ac:spMkLst>
          </pc:spChg>
          <pc:spChg chg="mod">
            <ac:chgData name="Ghosh, Souvik" userId="eecea02d-3ead-4d19-9bc6-c58aca595acd" providerId="ADAL" clId="{EB6CA0CA-B841-4CC5-9E0D-502717CC05FA}" dt="2022-10-31T15:04:53.889" v="0"/>
            <ac:spMkLst>
              <pc:docMk/>
              <pc:sldMasterMk cId="4045597202" sldId="2147483648"/>
              <pc:sldLayoutMk cId="190809347" sldId="2147483657"/>
              <ac:spMk id="3" creationId="{2D8B92E8-822B-49F3-ADC1-22E225DC4A2D}"/>
            </ac:spMkLst>
          </pc:spChg>
          <pc:spChg chg="mod">
            <ac:chgData name="Ghosh, Souvik" userId="eecea02d-3ead-4d19-9bc6-c58aca595acd" providerId="ADAL" clId="{EB6CA0CA-B841-4CC5-9E0D-502717CC05FA}" dt="2022-10-31T15:04:53.889" v="0"/>
            <ac:spMkLst>
              <pc:docMk/>
              <pc:sldMasterMk cId="4045597202" sldId="2147483648"/>
              <pc:sldLayoutMk cId="190809347" sldId="2147483657"/>
              <ac:spMk id="4" creationId="{818C3D99-4F2B-46CB-8277-1324B5C3A5EA}"/>
            </ac:spMkLst>
          </pc:spChg>
        </pc:sldLayoutChg>
        <pc:sldLayoutChg chg="modSp">
          <pc:chgData name="Ghosh, Souvik" userId="eecea02d-3ead-4d19-9bc6-c58aca595acd" providerId="ADAL" clId="{EB6CA0CA-B841-4CC5-9E0D-502717CC05FA}" dt="2022-10-31T15:04:53.889" v="0"/>
          <pc:sldLayoutMkLst>
            <pc:docMk/>
            <pc:sldMasterMk cId="4045597202" sldId="2147483648"/>
            <pc:sldLayoutMk cId="585685668" sldId="2147483659"/>
          </pc:sldLayoutMkLst>
          <pc:spChg chg="mod">
            <ac:chgData name="Ghosh, Souvik" userId="eecea02d-3ead-4d19-9bc6-c58aca595acd" providerId="ADAL" clId="{EB6CA0CA-B841-4CC5-9E0D-502717CC05FA}" dt="2022-10-31T15:04:53.889" v="0"/>
            <ac:spMkLst>
              <pc:docMk/>
              <pc:sldMasterMk cId="4045597202" sldId="2147483648"/>
              <pc:sldLayoutMk cId="585685668" sldId="2147483659"/>
              <ac:spMk id="2" creationId="{023E3E5F-DE5B-422C-813E-D104004CE81E}"/>
            </ac:spMkLst>
          </pc:spChg>
          <pc:spChg chg="mod">
            <ac:chgData name="Ghosh, Souvik" userId="eecea02d-3ead-4d19-9bc6-c58aca595acd" providerId="ADAL" clId="{EB6CA0CA-B841-4CC5-9E0D-502717CC05FA}" dt="2022-10-31T15:04:53.889" v="0"/>
            <ac:spMkLst>
              <pc:docMk/>
              <pc:sldMasterMk cId="4045597202" sldId="2147483648"/>
              <pc:sldLayoutMk cId="585685668" sldId="2147483659"/>
              <ac:spMk id="3" creationId="{0D3C0BC6-7BAB-4535-B95D-00134B847A83}"/>
            </ac:spMkLst>
          </pc:spChg>
        </pc:sldLayoutChg>
      </pc:sldMasterChg>
    </pc:docChg>
  </pc:docChgLst>
  <pc:docChgLst>
    <pc:chgData name="Ghosh, Souvik" userId="eecea02d-3ead-4d19-9bc6-c58aca595acd" providerId="ADAL" clId="{4BC70B35-8D31-4235-B07B-2433F8AF1C9F}"/>
    <pc:docChg chg="modSld">
      <pc:chgData name="Ghosh, Souvik" userId="eecea02d-3ead-4d19-9bc6-c58aca595acd" providerId="ADAL" clId="{4BC70B35-8D31-4235-B07B-2433F8AF1C9F}" dt="2023-01-07T16:29:22.113" v="1" actId="20577"/>
      <pc:docMkLst>
        <pc:docMk/>
      </pc:docMkLst>
      <pc:sldChg chg="modSp mod">
        <pc:chgData name="Ghosh, Souvik" userId="eecea02d-3ead-4d19-9bc6-c58aca595acd" providerId="ADAL" clId="{4BC70B35-8D31-4235-B07B-2433F8AF1C9F}" dt="2023-01-07T16:29:22.113" v="1" actId="20577"/>
        <pc:sldMkLst>
          <pc:docMk/>
          <pc:sldMk cId="2112372656" sldId="257"/>
        </pc:sldMkLst>
        <pc:spChg chg="mod">
          <ac:chgData name="Ghosh, Souvik" userId="eecea02d-3ead-4d19-9bc6-c58aca595acd" providerId="ADAL" clId="{4BC70B35-8D31-4235-B07B-2433F8AF1C9F}" dt="2023-01-07T16:29:22.113" v="1" actId="20577"/>
          <ac:spMkLst>
            <pc:docMk/>
            <pc:sldMk cId="2112372656" sldId="257"/>
            <ac:spMk id="4" creationId="{29D384DA-1FB8-7FF3-0040-8C715698B107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231FD-B328-4BCA-84E0-2BA1C76E13CA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89E48-E87E-442C-81EB-08DDD97C80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9672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231FD-B328-4BCA-84E0-2BA1C76E13CA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89E48-E87E-442C-81EB-08DDD97C80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7702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231FD-B328-4BCA-84E0-2BA1C76E13CA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89E48-E87E-442C-81EB-08DDD97C80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73708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231FD-B328-4BCA-84E0-2BA1C76E13CA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89E48-E87E-442C-81EB-08DDD97C80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15873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231FD-B328-4BCA-84E0-2BA1C76E13CA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89E48-E87E-442C-81EB-08DDD97C80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0848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231FD-B328-4BCA-84E0-2BA1C76E13CA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89E48-E87E-442C-81EB-08DDD97C80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8429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231FD-B328-4BCA-84E0-2BA1C76E13CA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89E48-E87E-442C-81EB-08DDD97C80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6562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231FD-B328-4BCA-84E0-2BA1C76E13CA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89E48-E87E-442C-81EB-08DDD97C80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9157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231FD-B328-4BCA-84E0-2BA1C76E13CA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89E48-E87E-442C-81EB-08DDD97C80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76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231FD-B328-4BCA-84E0-2BA1C76E13CA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89E48-E87E-442C-81EB-08DDD97C80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68993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231FD-B328-4BCA-84E0-2BA1C76E13CA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A89E48-E87E-442C-81EB-08DDD97C80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3880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0231FD-B328-4BCA-84E0-2BA1C76E13CA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A89E48-E87E-442C-81EB-08DDD97C80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24128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719FB7E-9452-4B63-ACD7-52EB685A922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" r="60169" b="73089"/>
          <a:stretch/>
        </p:blipFill>
        <p:spPr>
          <a:xfrm>
            <a:off x="321612" y="1819921"/>
            <a:ext cx="6477575" cy="597689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9D384DA-1FB8-7FF3-0040-8C715698B107}"/>
              </a:ext>
            </a:extLst>
          </p:cNvPr>
          <p:cNvSpPr txBox="1"/>
          <p:nvPr/>
        </p:nvSpPr>
        <p:spPr>
          <a:xfrm>
            <a:off x="262241" y="349776"/>
            <a:ext cx="6342745" cy="12264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6000"/>
              </a:lnSpc>
              <a:spcAft>
                <a:spcPts val="800"/>
              </a:spcAft>
            </a:pPr>
            <a:r>
              <a:rPr lang="en-US" sz="1000" b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US" sz="10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3. </a:t>
            </a:r>
            <a:r>
              <a:rPr lang="en-US" sz="10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ultiple alignment of the deduced amino acid (aa) sequences of the putative </a:t>
            </a:r>
            <a:r>
              <a:rPr lang="en-US" sz="10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psid (Cap) proteins of </a:t>
            </a:r>
            <a:r>
              <a:rPr lang="en-US" sz="10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11 </a:t>
            </a:r>
            <a:r>
              <a:rPr lang="en-US" sz="1000" i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rcine circovirus 3 </a:t>
            </a:r>
            <a:r>
              <a:rPr lang="en-US" sz="10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PCV3) strains from the Dominican Republic (DR) (</a:t>
            </a:r>
            <a:r>
              <a:rPr lang="en-US" sz="10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</a:t>
            </a:r>
            <a:r>
              <a:rPr lang="en-US" sz="10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ain name/year/host species/country/year/GenBank accession number) with the Cap of PCV3 reference strain (s</a:t>
            </a:r>
            <a:r>
              <a:rPr lang="en-US" sz="10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ain name</a:t>
            </a:r>
            <a:r>
              <a:rPr lang="en-US" sz="10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year/host species/country/year/GenBank accession number) NC_031753 (www.ncbi.nlm.nih.gov/genbank/, accessed on October 15</a:t>
            </a:r>
            <a:r>
              <a:rPr lang="en-US" sz="1000" baseline="300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</a:t>
            </a:r>
            <a:r>
              <a:rPr lang="en-US" sz="10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2022). The Cap of DR PCV3 strains exhibited 4 aa mismatches (position 24, 27, 77 and 150</a:t>
            </a:r>
            <a:r>
              <a:rPr lang="en-US" sz="1000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0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hown with green, yellow, red, and blue box, respectively) with that of strain NC_031753.  Numbers to the right indicate aa position for respective strains. </a:t>
            </a:r>
          </a:p>
        </p:txBody>
      </p:sp>
    </p:spTree>
    <p:extLst>
      <p:ext uri="{BB962C8B-B14F-4D97-AF65-F5344CB8AC3E}">
        <p14:creationId xmlns:p14="http://schemas.microsoft.com/office/powerpoint/2010/main" val="21123726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7C1558744F9E84F9DB11EE653CC9A55" ma:contentTypeVersion="14" ma:contentTypeDescription="Create a new document." ma:contentTypeScope="" ma:versionID="98c9b13aa71c527b7ced6f332a33a861">
  <xsd:schema xmlns:xsd="http://www.w3.org/2001/XMLSchema" xmlns:xs="http://www.w3.org/2001/XMLSchema" xmlns:p="http://schemas.microsoft.com/office/2006/metadata/properties" xmlns:ns3="84958558-c7aa-4a73-8d7b-4bffe5b377e9" xmlns:ns4="ebe390dc-a215-41b8-b9a7-475ecdd00c54" targetNamespace="http://schemas.microsoft.com/office/2006/metadata/properties" ma:root="true" ma:fieldsID="f478b27cdcb62a09c0a4e554e441f71e" ns3:_="" ns4:_="">
    <xsd:import namespace="84958558-c7aa-4a73-8d7b-4bffe5b377e9"/>
    <xsd:import namespace="ebe390dc-a215-41b8-b9a7-475ecdd00c54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4:MediaServiceDateTaken" minOccurs="0"/>
                <xsd:element ref="ns4:MediaLengthInSeconds" minOccurs="0"/>
                <xsd:element ref="ns4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4958558-c7aa-4a73-8d7b-4bffe5b377e9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description="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be390dc-a215-41b8-b9a7-475ecdd00c5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20" nillable="true" ma:displayName="Length (seconds)" ma:internalName="MediaLengthInSeconds" ma:readOnly="true">
      <xsd:simpleType>
        <xsd:restriction base="dms:Unknown"/>
      </xsd:simpleType>
    </xsd:element>
    <xsd:element name="MediaServiceLocation" ma:index="21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C032E858-6625-4ECC-8F55-310A7BF26EB9}">
  <ds:schemaRefs>
    <ds:schemaRef ds:uri="http://purl.org/dc/elements/1.1/"/>
    <ds:schemaRef ds:uri="http://schemas.microsoft.com/office/2006/metadata/properties"/>
    <ds:schemaRef ds:uri="http://schemas.microsoft.com/office/2006/documentManagement/types"/>
    <ds:schemaRef ds:uri="http://purl.org/dc/dcmitype/"/>
    <ds:schemaRef ds:uri="ebe390dc-a215-41b8-b9a7-475ecdd00c54"/>
    <ds:schemaRef ds:uri="http://purl.org/dc/terms/"/>
    <ds:schemaRef ds:uri="http://schemas.microsoft.com/office/infopath/2007/PartnerControls"/>
    <ds:schemaRef ds:uri="84958558-c7aa-4a73-8d7b-4bffe5b377e9"/>
    <ds:schemaRef ds:uri="http://schemas.openxmlformats.org/package/2006/metadata/core-properties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CC52EF31-E34E-486A-8F7C-403ED4975E8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CBA965B1-8BA7-484F-81FE-EEBE5EC112F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4958558-c7aa-4a73-8d7b-4bffe5b377e9"/>
    <ds:schemaRef ds:uri="ebe390dc-a215-41b8-b9a7-475ecdd00c5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157</Words>
  <Application>Microsoft Office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inor, Kerry</dc:creator>
  <cp:lastModifiedBy>MDPI</cp:lastModifiedBy>
  <cp:revision>3</cp:revision>
  <dcterms:created xsi:type="dcterms:W3CDTF">2022-10-31T13:38:43Z</dcterms:created>
  <dcterms:modified xsi:type="dcterms:W3CDTF">2023-02-04T07:17:1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7C1558744F9E84F9DB11EE653CC9A55</vt:lpwstr>
  </property>
</Properties>
</file>